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21" autoAdjust="0"/>
    <p:restoredTop sz="99901" autoAdjust="0"/>
  </p:normalViewPr>
  <p:slideViewPr>
    <p:cSldViewPr snapToGrid="0" snapToObjects="1">
      <p:cViewPr>
        <p:scale>
          <a:sx n="200" d="100"/>
          <a:sy n="200" d="100"/>
        </p:scale>
        <p:origin x="-248" y="53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920301-DCB5-3848-930D-6C078674DB53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BC0EA8-D580-C947-9062-0F48C0E007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23082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77748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7184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846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241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4776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359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189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676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562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5076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635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0554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5030843"/>
              </p:ext>
            </p:extLst>
          </p:nvPr>
        </p:nvGraphicFramePr>
        <p:xfrm>
          <a:off x="379181" y="372534"/>
          <a:ext cx="4680521" cy="7148382"/>
        </p:xfrm>
        <a:graphic>
          <a:graphicData uri="http://schemas.openxmlformats.org/drawingml/2006/table">
            <a:tbl>
              <a:tblPr/>
              <a:tblGrid>
                <a:gridCol w="518012"/>
                <a:gridCol w="432828"/>
                <a:gridCol w="269365"/>
                <a:gridCol w="1263947"/>
                <a:gridCol w="794285"/>
                <a:gridCol w="690681"/>
                <a:gridCol w="711403"/>
              </a:tblGrid>
              <a:tr h="7023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0238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Table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1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. The patients' background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Patient #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ge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ex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Disease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ast cell origin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ast cell (%)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ean±SE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2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arcoidos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05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11</a:t>
                      </a:r>
                      <a:b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</a:br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±0.046 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arcoidos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75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3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arcoidos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42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3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arcoidos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52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3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arcoidos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09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8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arcoidosi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449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7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arcoidos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06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8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3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arcoidos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03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9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arcoidos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59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5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IP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622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74</a:t>
                      </a:r>
                      <a:b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</a:br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±0.076 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1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IP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84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2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9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IP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70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3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6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IP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20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4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IP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36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5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8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IP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30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6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9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IP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59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7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1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VD-ILD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10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99</a:t>
                      </a:r>
                      <a:b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</a:br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±0.075 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8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4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VD-ILD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396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9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1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VD-ILD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87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1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VD-ILD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&lt;0.001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1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5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VD-ILD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&lt;0.001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2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5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Eosinophilc penumonia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24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247</a:t>
                      </a:r>
                      <a:b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</a:br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±0.229 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3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9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Eosinophilc penumonia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706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4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9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Eosinophilc penumonia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12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5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7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nfectious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pneumoni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661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232</a:t>
                      </a:r>
                      <a:b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</a:br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±0.217 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6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8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nfectious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pneumoni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02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7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2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nfectious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pneumoni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33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8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6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gG4-related disease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AL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29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　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9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9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ontrol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&lt;0.001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02</a:t>
                      </a:r>
                      <a:b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</a:br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±0.000 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ontrol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02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1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3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ontrol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&lt;0.001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2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ontrol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03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3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4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ontrol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&lt;0.001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4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hinit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05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318</a:t>
                      </a:r>
                      <a:b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</a:br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±0.115 %</a:t>
                      </a:r>
                      <a:r>
                        <a:rPr lang="ja-JP" altLang="en-US" sz="900" b="1" i="0" u="none" strike="noStrike" baseline="3000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*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5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3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hinit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227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6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8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hinit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82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7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5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hinit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30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8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7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hinit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809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9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6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hinit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390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0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8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hinit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977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1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4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hinit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97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2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2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hiniti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SS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46%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03862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IP; idiopathic interstitial pneumonia, CVD-ILD; collagen vascular disease associated interstitial lung disease, BALF;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ronchoalveolar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lavage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luid, NSS; nasal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cratching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pecimen, *P=0.0032 compared to control</a:t>
                      </a: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7023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3127" marR="3127" marT="31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0644244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6</TotalTime>
  <Words>385</Words>
  <Application>Microsoft Macintosh PowerPoint</Application>
  <PresentationFormat>画面に合わせる (4:3)</PresentationFormat>
  <Paragraphs>26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永井 恵</dc:creator>
  <cp:lastModifiedBy>永井 恵</cp:lastModifiedBy>
  <cp:revision>41</cp:revision>
  <dcterms:created xsi:type="dcterms:W3CDTF">2013-06-24T12:55:05Z</dcterms:created>
  <dcterms:modified xsi:type="dcterms:W3CDTF">2013-08-29T05:27:32Z</dcterms:modified>
</cp:coreProperties>
</file>